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F7B7A-94F4-4941-AFE7-FFB7A49E6F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AAA76C-030D-4BA9-A4D2-F7D5532777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5DAB9E-FAC7-42B1-B18B-93AF9BAD1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BECF3A-BFC8-480B-BD89-C0AD36AFD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4A89A-D45F-4A6E-BF77-86D328E79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74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F8F47-6FC7-4A19-8968-E583589BE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D7EDBA-0943-447F-9BF4-5D683C21F5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A58801-C8E5-4CAC-932E-E2C81A9D1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B51F5E-9065-4D77-A7EA-530ED8557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C7CFB6-FEDD-416E-9075-865BF92FE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5118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0340BC-B9F0-4B82-9DA0-6C44143238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C76880-97C5-4B1B-B8E3-3BA9BBC6A8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B7AC05-17CD-4196-B49C-EE0CA2AED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78A253-AC22-4C39-B6BE-6C0B46C1E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48341E-52FA-4283-A706-18B75675A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880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68BF3-9C62-4A7E-98B7-CD0813CC70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3F2B0D-C71A-4595-9BB2-FDF0C2EC4B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06890-D5E0-4DFD-A5E8-57AA948B6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084B1F-4B9C-4D9E-9639-0A31597CA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CDF632-039E-418D-85DC-772BF4C9C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844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8CE1C-E795-472D-8ED6-2F13B6092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DAF087-899D-4917-AF05-B39E0E8B97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9FDFAD-4F7E-4C56-BA74-D99A1AC09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848B2-54E4-4FB0-AD12-78C27AED7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D3606F-B144-4785-A660-84B38DC8F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57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287F82-7D18-4716-A500-534C5A6DA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4843F4-94EA-4D04-8101-33C3A08A18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B15F53-8FE0-4F44-8DCE-D943CB04AD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33F71-6192-476A-81D3-6540C9D02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15AD06-2120-4543-B8AC-59F8938E9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48FA5-B1B6-4971-B37E-AC016DA35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514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A4F787-5B54-4479-80CB-D5C4D6DE7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79902D-E1FF-499A-865F-258DF9F4E3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BD0CBB-ABA5-4C3B-A6E8-282E0840F3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EBC3CE-C5B4-4AA1-B974-30B7E53A43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C45DF9-7D86-42B6-A5E1-11A481541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B84805-9B63-48D6-A732-CBC5A0B4A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9E08D1-29FE-42D5-929B-9CEFD90DE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AE6368-C603-47D4-A556-9C671E99D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8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8799CF-060E-4831-B3A5-FD7E04288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AB88E6-6483-45FC-BA31-F747686E6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FE1769-77FB-49F7-B9B8-C3640E489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F87BB8-75FB-4F3D-B445-ACF9C8126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92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81BF8B-81D1-46ED-B94B-94F409185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398968-E618-42CA-B440-3D3E27E05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73A877-09A2-4A82-B7CA-5E4ADE5A5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0393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E2EC7A-4C52-45CA-B560-0CE7A00D2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E03D9D-73DB-4B23-819F-C054CB985C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4DAB5C-6EFC-48A6-B38A-B7B9EA839B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346E8A-8C1D-4872-AABD-20EF2D3D6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E52AD2-6C1F-4634-B978-BF5D207BF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4C82DD-BEB6-4EEB-8833-4EB037B82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4442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4EE818-3C75-4885-B219-4750DECD3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7B6A04-F1F7-497F-BB23-7265D967FF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A4517A-8867-44F2-8ADF-AE1407DB32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319688-6ECF-48E0-B0F2-14352C4EA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7C37C-A8F3-43F6-9A2E-D9EF6682E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0D283B-8879-4C9F-A88B-32BD6DF2F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474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2F5740-557F-4AD1-ACCD-72672FBA4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AB72-0790-484A-964E-E07416C2D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90794-7A9B-4CDA-9747-16498935C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986AB-D2A6-4E58-9292-599C9D503F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5E9F3-D185-4DFA-B935-33FD09745E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8A1E25-FF40-4A1F-9A5E-E1EE3933D0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BE382C-03A7-409D-B154-6128D33903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1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0306C2D-AEF5-4DFA-B551-4A1D7AF25FAD}"/>
              </a:ext>
            </a:extLst>
          </p:cNvPr>
          <p:cNvSpPr txBox="1"/>
          <p:nvPr/>
        </p:nvSpPr>
        <p:spPr>
          <a:xfrm>
            <a:off x="7998244" y="1189546"/>
            <a:ext cx="3327096" cy="67710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sz="1400" dirty="0"/>
          </a:p>
          <a:p>
            <a:endParaRPr lang="en-GB" sz="1200" b="1" dirty="0"/>
          </a:p>
          <a:p>
            <a:r>
              <a:rPr lang="en-GB" sz="1200" b="1" dirty="0"/>
              <a:t>              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35B23284-8079-43A5-B314-771C217371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9190" y="142244"/>
            <a:ext cx="9277350" cy="4524375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0479BBE2-5411-4CF9-81EE-9694206F0331}"/>
              </a:ext>
            </a:extLst>
          </p:cNvPr>
          <p:cNvSpPr/>
          <p:nvPr/>
        </p:nvSpPr>
        <p:spPr>
          <a:xfrm>
            <a:off x="947737" y="4790591"/>
            <a:ext cx="102965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>
                <a:solidFill>
                  <a:srgbClr val="000000"/>
                </a:solidFill>
              </a:rPr>
              <a:t>Supplementary </a:t>
            </a:r>
            <a:r>
              <a:rPr lang="en-GB" sz="1600" b="1">
                <a:solidFill>
                  <a:srgbClr val="000000"/>
                </a:solidFill>
              </a:rPr>
              <a:t>Figure S2</a:t>
            </a:r>
            <a:r>
              <a:rPr lang="en-GB" sz="1600" b="1" dirty="0">
                <a:solidFill>
                  <a:srgbClr val="000000"/>
                </a:solidFill>
              </a:rPr>
              <a:t>. Heatmap comparison of transcript profiles of orange and border carrot regions (A) and </a:t>
            </a:r>
            <a:r>
              <a:rPr lang="en-GB" sz="1600" b="1" dirty="0"/>
              <a:t>orange and blackened carrot regions (B)</a:t>
            </a:r>
            <a:r>
              <a:rPr lang="en-GB" sz="1600" b="1" dirty="0">
                <a:solidFill>
                  <a:srgbClr val="000000"/>
                </a:solidFill>
              </a:rPr>
              <a:t>. </a:t>
            </a:r>
            <a:r>
              <a:rPr lang="en-GB" sz="1600" dirty="0">
                <a:solidFill>
                  <a:srgbClr val="000000"/>
                </a:solidFill>
              </a:rPr>
              <a:t>P-values were calculated using Deseq2 tool and later adjusted using </a:t>
            </a:r>
            <a:r>
              <a:rPr lang="en-GB" sz="1600" dirty="0"/>
              <a:t>Benjamin-Hochberg correction </a:t>
            </a:r>
            <a:r>
              <a:rPr lang="en-GB" sz="1600" dirty="0">
                <a:solidFill>
                  <a:srgbClr val="000000"/>
                </a:solidFill>
              </a:rPr>
              <a:t>(p&lt;0.05). </a:t>
            </a:r>
            <a:endParaRPr lang="en-GB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1E0610D-90AB-0E2D-AD1D-F1B905AA7F30}"/>
              </a:ext>
            </a:extLst>
          </p:cNvPr>
          <p:cNvSpPr txBox="1"/>
          <p:nvPr/>
        </p:nvSpPr>
        <p:spPr>
          <a:xfrm>
            <a:off x="1379941" y="265785"/>
            <a:ext cx="53810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                         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2095977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2</TotalTime>
  <Words>4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Karpinska (Biosciences)</dc:creator>
  <cp:lastModifiedBy>MDPI</cp:lastModifiedBy>
  <cp:revision>55</cp:revision>
  <dcterms:created xsi:type="dcterms:W3CDTF">2023-03-12T01:24:27Z</dcterms:created>
  <dcterms:modified xsi:type="dcterms:W3CDTF">2023-10-16T09:52:11Z</dcterms:modified>
</cp:coreProperties>
</file>